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6"/>
    <p:restoredTop sz="94581"/>
  </p:normalViewPr>
  <p:slideViewPr>
    <p:cSldViewPr snapToGrid="0" snapToObjects="1">
      <p:cViewPr varScale="1">
        <p:scale>
          <a:sx n="68" d="100"/>
          <a:sy n="68" d="100"/>
        </p:scale>
        <p:origin x="2104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2122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9906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6206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7862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0557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96467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3646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5465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4169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6440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2428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B4870D-332D-6C49-BA43-3C03384B16FF}" type="datetimeFigureOut">
              <a:rPr lang="es-ES" smtClean="0"/>
              <a:t>1/4/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C738E8-E6CB-5E45-8A2A-8163332D574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4316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8C45427-B531-764E-9339-32ED8C91092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754" t="20132" r="10434" b="23057"/>
          <a:stretch/>
        </p:blipFill>
        <p:spPr>
          <a:xfrm>
            <a:off x="3551481" y="1517301"/>
            <a:ext cx="3233416" cy="239150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42F586A-A882-0C43-8667-C5A0A4401E0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266" t="19855" r="5507" b="25371"/>
          <a:stretch/>
        </p:blipFill>
        <p:spPr>
          <a:xfrm>
            <a:off x="119227" y="4243652"/>
            <a:ext cx="3227646" cy="238179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DCC5DA0-2122-D04D-8AD3-A27B2511EED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801" t="22850" r="16996" b="18757"/>
          <a:stretch/>
        </p:blipFill>
        <p:spPr>
          <a:xfrm>
            <a:off x="119227" y="1517301"/>
            <a:ext cx="3227646" cy="253993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3F34BFD-7737-B440-8BA9-FBE5EC5F60D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870" t="6816" r="1119" b="31044"/>
          <a:stretch/>
        </p:blipFill>
        <p:spPr>
          <a:xfrm>
            <a:off x="3478378" y="4340888"/>
            <a:ext cx="3379622" cy="218732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A9D6C54-2A82-5844-99BB-3953473D0264}"/>
              </a:ext>
            </a:extLst>
          </p:cNvPr>
          <p:cNvSpPr txBox="1"/>
          <p:nvPr/>
        </p:nvSpPr>
        <p:spPr>
          <a:xfrm>
            <a:off x="321548" y="1517301"/>
            <a:ext cx="13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nti-DNMT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3DC45B-92F7-4646-AEA6-BF9F7FD528D1}"/>
              </a:ext>
            </a:extLst>
          </p:cNvPr>
          <p:cNvSpPr txBox="1"/>
          <p:nvPr/>
        </p:nvSpPr>
        <p:spPr>
          <a:xfrm>
            <a:off x="3701634" y="1497204"/>
            <a:ext cx="14665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nti-DNMT3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63C1EAC-E835-6149-BBC9-B0F9AE36B70F}"/>
              </a:ext>
            </a:extLst>
          </p:cNvPr>
          <p:cNvSpPr txBox="1"/>
          <p:nvPr/>
        </p:nvSpPr>
        <p:spPr>
          <a:xfrm>
            <a:off x="255273" y="4320791"/>
            <a:ext cx="1477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nti-DNMT3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B918877-9033-0140-9B16-2BCE5A213955}"/>
              </a:ext>
            </a:extLst>
          </p:cNvPr>
          <p:cNvSpPr txBox="1"/>
          <p:nvPr/>
        </p:nvSpPr>
        <p:spPr>
          <a:xfrm>
            <a:off x="3571000" y="4320791"/>
            <a:ext cx="11186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nti-FLAG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A036EA2-F384-0E46-A2F0-BA880EE744FD}"/>
              </a:ext>
            </a:extLst>
          </p:cNvPr>
          <p:cNvSpPr txBox="1"/>
          <p:nvPr/>
        </p:nvSpPr>
        <p:spPr>
          <a:xfrm>
            <a:off x="116940" y="1147969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5E5AC45-6E37-9349-A342-4791E2B6EBBF}"/>
              </a:ext>
            </a:extLst>
          </p:cNvPr>
          <p:cNvSpPr txBox="1"/>
          <p:nvPr/>
        </p:nvSpPr>
        <p:spPr>
          <a:xfrm>
            <a:off x="3590756" y="113792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93A5862-4B61-0043-BE0C-3FBC1B133F70}"/>
              </a:ext>
            </a:extLst>
          </p:cNvPr>
          <p:cNvSpPr txBox="1"/>
          <p:nvPr/>
        </p:nvSpPr>
        <p:spPr>
          <a:xfrm>
            <a:off x="129764" y="3981604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90785B3-B876-B74B-8EDD-B50D72684167}"/>
              </a:ext>
            </a:extLst>
          </p:cNvPr>
          <p:cNvSpPr txBox="1"/>
          <p:nvPr/>
        </p:nvSpPr>
        <p:spPr>
          <a:xfrm>
            <a:off x="3590756" y="398160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B416AE-8498-804F-909B-E9B59BBD51D8}"/>
              </a:ext>
            </a:extLst>
          </p:cNvPr>
          <p:cNvSpPr txBox="1"/>
          <p:nvPr/>
        </p:nvSpPr>
        <p:spPr>
          <a:xfrm>
            <a:off x="321548" y="571500"/>
            <a:ext cx="4918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Uncropped</a:t>
            </a:r>
            <a:r>
              <a:rPr lang="es-ES" dirty="0"/>
              <a:t> </a:t>
            </a:r>
            <a:r>
              <a:rPr lang="es-ES" dirty="0" err="1"/>
              <a:t>blots</a:t>
            </a:r>
            <a:r>
              <a:rPr lang="es-ES" dirty="0"/>
              <a:t> </a:t>
            </a:r>
            <a:r>
              <a:rPr lang="es-ES" dirty="0" err="1"/>
              <a:t>shown</a:t>
            </a:r>
            <a:r>
              <a:rPr lang="es-ES" dirty="0"/>
              <a:t> in </a:t>
            </a:r>
            <a:r>
              <a:rPr lang="es-ES" dirty="0" err="1"/>
              <a:t>supplementary</a:t>
            </a:r>
            <a:r>
              <a:rPr lang="es-ES" dirty="0"/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3124511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15</Words>
  <Application>Microsoft Macintosh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</cp:revision>
  <dcterms:created xsi:type="dcterms:W3CDTF">2021-03-31T14:28:29Z</dcterms:created>
  <dcterms:modified xsi:type="dcterms:W3CDTF">2021-04-01T08:05:40Z</dcterms:modified>
</cp:coreProperties>
</file>